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6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9924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144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7532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9627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4060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5850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2329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6327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8888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5452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842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89CE9C-043F-4A1A-9A38-3849444BFA44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D8E37-A821-4728-A1FE-7C1CBA9FFC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693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MAH00638">
            <a:hlinkClick r:id="" action="ppaction://media"/>
            <a:extLst>
              <a:ext uri="{FF2B5EF4-FFF2-40B4-BE49-F238E27FC236}">
                <a16:creationId xmlns:a16="http://schemas.microsoft.com/office/drawing/2014/main" id="{0964D9F4-C36E-4E6F-B1C7-D091AE78668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4933" y="1085801"/>
            <a:ext cx="9074134" cy="5104200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 flipV="1">
            <a:off x="1268627" y="5544066"/>
            <a:ext cx="396000" cy="2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D313B4B5-C735-4852-8A8A-5232D6E60544}"/>
              </a:ext>
            </a:extLst>
          </p:cNvPr>
          <p:cNvSpPr txBox="1"/>
          <p:nvPr/>
        </p:nvSpPr>
        <p:spPr>
          <a:xfrm>
            <a:off x="204716" y="241156"/>
            <a:ext cx="87345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Video S1.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one-year-old culture of the </a:t>
            </a:r>
            <a:r>
              <a:rPr lang="en-GB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atoma infestans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line TIE/LULS54 at passage 3, showing a continuously contracting lattice of muscle cells above a discontinuous monolayer of rounded cells. Recorded in real time; scale bar 100 µm.</a:t>
            </a:r>
          </a:p>
        </p:txBody>
      </p:sp>
    </p:spTree>
    <p:extLst>
      <p:ext uri="{BB962C8B-B14F-4D97-AF65-F5344CB8AC3E}">
        <p14:creationId xmlns:p14="http://schemas.microsoft.com/office/powerpoint/2010/main" val="25567655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14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 mute="1">
                <p:cTn id="1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8</TotalTime>
  <Words>45</Words>
  <Application>Microsoft Office PowerPoint</Application>
  <PresentationFormat>On-screen Show (4:3)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kyi, Lesley</dc:creator>
  <cp:lastModifiedBy>Sakyi, Lesley</cp:lastModifiedBy>
  <cp:revision>21</cp:revision>
  <dcterms:created xsi:type="dcterms:W3CDTF">2022-01-30T16:21:09Z</dcterms:created>
  <dcterms:modified xsi:type="dcterms:W3CDTF">2022-09-06T09:38:00Z</dcterms:modified>
</cp:coreProperties>
</file>